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296"/>
  </p:normalViewPr>
  <p:slideViewPr>
    <p:cSldViewPr snapToGrid="0">
      <p:cViewPr varScale="1">
        <p:scale>
          <a:sx n="127" d="100"/>
          <a:sy n="127" d="100"/>
        </p:scale>
        <p:origin x="53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72EA61-A147-CA4B-9AC3-19750D81BB1A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D95B7A-ECA5-0442-AF1A-D89D4058B17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0261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3. </a:t>
            </a:r>
            <a:r>
              <a:rPr lang="en-US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lR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presses the expression and secretion of proteins encoded in the LEE island under conditions in which </a:t>
            </a:r>
            <a:r>
              <a:rPr lang="en-US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lA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not the main activator of </a:t>
            </a:r>
            <a:r>
              <a:rPr lang="en-US" sz="1200" b="1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r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A) Profile of secreted proteins from WT EPEC and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itchFamily="2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n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trains carrying the empty vector pMPMT-3 or its derivative pT3GrlR. Bacteria were grown under static conditions in 50 ml DMEM at 37°C with 5% CO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t an OD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00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0.8. Secreted proteins were concentrated from culture supernatants by TCA precipitation and separated by 12% SDS-PAGE. (B) Total extracts were prepared from the same strains described in (A) grown in 50 ml DMEM and incubated under shaking (37°C with shaking) and static (37°C with 5% CO2) conditions, at an OD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00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0.8. Extracts were separated by 12% SDS-PAGE and intimin an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sp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pression was analyzed by Western blotting using anti-intimin and anti-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sp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tibodies. As a control for protein loading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naK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pression was also analyzed using anti-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naK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tibodies.</a:t>
            </a:r>
            <a:endParaRPr lang="es-MX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sz="1200" b="1" i="1" kern="1200" noProof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2AC7A1-2280-DD4D-B9A9-0B61BEE54FA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2123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79F99B3-F533-60A1-3839-BD61F931A5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EC63667-BFA6-900C-E77D-C3F30A0DDC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MX"/>
              <a:t>Haz clic para edit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2DD05E9-C3B7-58A7-A3BA-2F1CF787F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3E66EC8-08BD-39E9-D38A-3F343967B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4086838-FBE3-A387-36F8-06BE99D59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89463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CA47A85-EE9D-148D-A566-61CA42355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2F5FE46-FB12-F6E3-A3E9-67A73101A5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0D9AEF2-4B39-DE8F-978E-B9E5287B7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25C2DBE-7392-A3E4-6A21-60D4FE9AD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E2A21BA-D96B-849B-2C6E-CCAD1F16A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71853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CFAADF7-05F8-5205-DA40-1159E09952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DF1767C-12D8-699A-CE05-366C795F39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FF067E8-9B39-F73F-EB72-277D88585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AE4D90C-80D6-4BFA-2F39-46951F70A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BB4402A-A9EF-8FF2-24C5-D2B631669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48081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37556E3-4C9E-86EC-2C11-3CDA41157A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471382F-9EE8-BA1E-5DC1-A09EC3A7DA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8246315-BEBC-3193-06FB-112436547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90D6F8D-4311-8F96-2D4E-D226BA6D4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225A8C9-54EE-A4F5-9CCA-2A7C0966F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99330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BA7938-4644-743B-3583-3D334F83C4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DF061FE-7C07-F92A-29C8-F3A3CE3F0A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CEBCD28-D266-6CDB-F001-5D99BDFAA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2D02DC3-5E01-F368-85DC-0DC57B388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AE176A5-5C21-2019-ACB2-75548D04A2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14276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63F859C-FDD0-72FA-97BA-E5A1B30AB9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CD799BE-299B-F0B9-6E52-5C0E5A8161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FE122B1-C068-5242-FA21-84D31952BD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4E481BA-F51D-7F49-9B47-3DB8B4AC1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DE0D82E-3F39-B409-6E96-688BA9BE53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B41EE14-B90C-6CD6-9418-480E54948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43654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FAC0518-70BB-0F87-8653-783CB27334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8169FD6-9BD0-1342-074A-19DB447F4A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0BCD0E2-DE11-C18B-08AC-33AFAC038C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A751A3CB-CC53-5F42-04AD-10FF0BAB35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AAC131B2-5630-B15F-9A54-5820B9C768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9E0BCB83-A99E-0F94-011C-E6E727AAF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92D14CBB-5E4F-FBA9-9761-03B84440D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14AC8EF-BEA1-BCB3-9CBC-DBA72BCC9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06874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F117E29-BB4B-2C79-3CBE-64533FF3CA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06DF935-EB07-51BF-1636-07E0D70BA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56F3878-D12C-16DA-B60B-77A074113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E1640610-435D-E64E-4CED-58330404F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35690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5DA26DE-D585-2586-4BB5-B0D17CFEB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FAB5779-A67B-9592-6401-2A9754722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76CFC158-718C-D22F-527C-B9448CFA3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09912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AC63C83-E024-DAEC-5A42-8FCAC9084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D341AD3-EE49-97B8-1915-834C02089F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41494BF-8486-102D-B786-F781C68377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B543EAC-C06E-4CDE-F67A-D96AD7945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F0D9579-A339-D7EB-18E5-535B1D00E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7253FE1-994E-B63F-74FB-DCF34E428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56909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59574F-BECB-7174-9A3A-F7FA9D917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E8FBB83C-9D9B-7139-F20A-BFDCCF6CDF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9E76438-1B97-F73D-1600-E1788DB075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B3EC9E2-A6BB-CDB6-8DD8-53DAA20FA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958B82E-374A-D0C9-F418-7B804DD88A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FA39E06-E93E-C33A-6172-2CA1422EA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08815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40A1C2B-7417-244A-083D-AFD1389833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5639EC4-623F-14A7-561E-6A052E5C27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75D4317-B211-8F92-96F0-4D415214AC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DF08EF-D1A0-0B45-9106-2A827AAB5A68}" type="datetimeFigureOut">
              <a:rPr lang="es-MX" smtClean="0"/>
              <a:t>06/10/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289AB5E-89D7-C01B-CB7D-6229BCE399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162725A-EE73-EC9A-801F-C3F646D038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1B203-01D0-5C48-B800-EDFC211D8F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76842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5 CuadroTexto">
            <a:extLst>
              <a:ext uri="{FF2B5EF4-FFF2-40B4-BE49-F238E27FC236}">
                <a16:creationId xmlns:a16="http://schemas.microsoft.com/office/drawing/2014/main" id="{079D84D1-DBC0-1047-85EF-F6DCF02603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22" y="571119"/>
            <a:ext cx="38222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s-MX" altLang="en-US" sz="1600" b="1">
                <a:cs typeface="Arial" panose="020B0604020202020204" pitchFamily="34" charset="0"/>
              </a:rPr>
              <a:t>A </a:t>
            </a:r>
          </a:p>
        </p:txBody>
      </p:sp>
      <p:pic>
        <p:nvPicPr>
          <p:cNvPr id="15" name="Picture 2">
            <a:extLst>
              <a:ext uri="{FF2B5EF4-FFF2-40B4-BE49-F238E27FC236}">
                <a16:creationId xmlns:a16="http://schemas.microsoft.com/office/drawing/2014/main" id="{9667FF1B-AA99-4E44-A56F-5599F9437F8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lum bright="18000" contrast="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84" r="6566" b="23529"/>
          <a:stretch/>
        </p:blipFill>
        <p:spPr bwMode="auto">
          <a:xfrm>
            <a:off x="1545550" y="1819222"/>
            <a:ext cx="3890050" cy="2165892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16" name="Group 118">
            <a:extLst>
              <a:ext uri="{FF2B5EF4-FFF2-40B4-BE49-F238E27FC236}">
                <a16:creationId xmlns:a16="http://schemas.microsoft.com/office/drawing/2014/main" id="{BE558B2B-C899-754A-B8A4-4546029F13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9391148"/>
              </p:ext>
            </p:extLst>
          </p:nvPr>
        </p:nvGraphicFramePr>
        <p:xfrm>
          <a:off x="829662" y="1098554"/>
          <a:ext cx="4605937" cy="708678"/>
        </p:xfrm>
        <a:graphic>
          <a:graphicData uri="http://schemas.openxmlformats.org/drawingml/2006/table">
            <a:tbl>
              <a:tblPr/>
              <a:tblGrid>
                <a:gridCol w="7140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915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4190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269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9232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797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2549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0372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endParaRPr kumimoji="0" lang="es-ES_tradnl" altLang="es-MX" sz="105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pitchFamily="34" charset="-128"/>
                        <a:cs typeface="Arial" panose="020B0604020202020204" pitchFamily="34" charset="0"/>
                      </a:endParaRPr>
                    </a:p>
                  </a:txBody>
                  <a:tcPr marL="30480" marR="30480" marT="38103" marB="38103" anchor="ctr" horzOverflow="overflow">
                    <a:lnL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EPEC WT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gridSpan="3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EPEC ∆</a:t>
                      </a:r>
                      <a:r>
                        <a:rPr kumimoji="0" lang="es-ES_tradnl" altLang="es-MX" sz="1050" b="1" i="1" u="none" strike="noStrike" cap="none" normalizeH="0" baseline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hns</a:t>
                      </a:r>
                      <a:endParaRPr kumimoji="0" lang="es-ES_tradnl" altLang="es-MX" sz="105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pitchFamily="34" charset="-128"/>
                        <a:cs typeface="Arial" panose="020B0604020202020204" pitchFamily="34" charset="0"/>
                      </a:endParaRPr>
                    </a:p>
                  </a:txBody>
                  <a:tcPr marL="81280" marR="81280" marT="38103" marB="3810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108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pMPM-T3</a:t>
                      </a:r>
                      <a:endParaRPr kumimoji="0" lang="es-ES_tradnl" altLang="es-MX" sz="105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pitchFamily="34" charset="-128"/>
                        <a:cs typeface="Arial" panose="020B0604020202020204" pitchFamily="34" charset="0"/>
                      </a:endParaRPr>
                    </a:p>
                  </a:txBody>
                  <a:tcPr marL="30480" marR="304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108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pT3GrlR</a:t>
                      </a:r>
                      <a:endParaRPr kumimoji="0" lang="es-ES_tradnl" altLang="es-MX" sz="105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pitchFamily="34" charset="-128"/>
                        <a:cs typeface="Arial" panose="020B0604020202020204" pitchFamily="34" charset="0"/>
                      </a:endParaRPr>
                    </a:p>
                  </a:txBody>
                  <a:tcPr marL="30480" marR="304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3" name="5 CuadroTexto">
            <a:extLst>
              <a:ext uri="{FF2B5EF4-FFF2-40B4-BE49-F238E27FC236}">
                <a16:creationId xmlns:a16="http://schemas.microsoft.com/office/drawing/2014/main" id="{D1B1849B-466E-8B40-8554-64BD30FA54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98851" y="672719"/>
            <a:ext cx="38985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s-MX" altLang="en-US" sz="1600" b="1">
                <a:cs typeface="Arial" panose="020B0604020202020204" pitchFamily="34" charset="0"/>
              </a:rPr>
              <a:t>B </a:t>
            </a:r>
          </a:p>
        </p:txBody>
      </p:sp>
      <p:pic>
        <p:nvPicPr>
          <p:cNvPr id="27" name="Picture 2">
            <a:extLst>
              <a:ext uri="{FF2B5EF4-FFF2-40B4-BE49-F238E27FC236}">
                <a16:creationId xmlns:a16="http://schemas.microsoft.com/office/drawing/2014/main" id="{0BF0672C-0386-EB48-8268-B41A2FD13DC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99" t="14412" r="1276" b="18333"/>
          <a:stretch/>
        </p:blipFill>
        <p:spPr bwMode="auto">
          <a:xfrm>
            <a:off x="7785099" y="2166969"/>
            <a:ext cx="3505201" cy="477359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3">
            <a:extLst>
              <a:ext uri="{FF2B5EF4-FFF2-40B4-BE49-F238E27FC236}">
                <a16:creationId xmlns:a16="http://schemas.microsoft.com/office/drawing/2014/main" id="{F822DB77-F768-3345-AA86-1DC05AF7D85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lum bright="20000" contrast="10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1" t="11243" r="2832" b="2479"/>
          <a:stretch/>
        </p:blipFill>
        <p:spPr bwMode="auto">
          <a:xfrm>
            <a:off x="7785099" y="2855061"/>
            <a:ext cx="3505201" cy="827973"/>
          </a:xfrm>
          <a:prstGeom prst="rect">
            <a:avLst/>
          </a:prstGeom>
          <a:noFill/>
          <a:ln w="222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9" name="20 CuadroTexto">
            <a:extLst>
              <a:ext uri="{FF2B5EF4-FFF2-40B4-BE49-F238E27FC236}">
                <a16:creationId xmlns:a16="http://schemas.microsoft.com/office/drawing/2014/main" id="{7573654B-5295-B442-AAC5-14D793E147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43855" y="966458"/>
            <a:ext cx="73129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s-MX" altLang="es-MX" sz="1200" b="1"/>
              <a:t>Shaken</a:t>
            </a:r>
          </a:p>
        </p:txBody>
      </p:sp>
      <p:sp>
        <p:nvSpPr>
          <p:cNvPr id="40" name="21 CuadroTexto">
            <a:extLst>
              <a:ext uri="{FF2B5EF4-FFF2-40B4-BE49-F238E27FC236}">
                <a16:creationId xmlns:a16="http://schemas.microsoft.com/office/drawing/2014/main" id="{D837354F-CD5C-EE49-BC38-A8DF216A2D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12508" y="966458"/>
            <a:ext cx="6030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s-MX" altLang="es-MX" sz="1200" b="1"/>
              <a:t>Static</a:t>
            </a:r>
          </a:p>
        </p:txBody>
      </p:sp>
      <p:graphicFrame>
        <p:nvGraphicFramePr>
          <p:cNvPr id="58" name="Group 118">
            <a:extLst>
              <a:ext uri="{FF2B5EF4-FFF2-40B4-BE49-F238E27FC236}">
                <a16:creationId xmlns:a16="http://schemas.microsoft.com/office/drawing/2014/main" id="{8FE5E126-74C0-7C45-A02D-9BABD7066C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3892926"/>
              </p:ext>
            </p:extLst>
          </p:nvPr>
        </p:nvGraphicFramePr>
        <p:xfrm>
          <a:off x="6888591" y="1246095"/>
          <a:ext cx="4401709" cy="883932"/>
        </p:xfrm>
        <a:graphic>
          <a:graphicData uri="http://schemas.openxmlformats.org/drawingml/2006/table">
            <a:tbl>
              <a:tblPr/>
              <a:tblGrid>
                <a:gridCol w="9012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65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63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4843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7369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48434">
                  <a:extLst>
                    <a:ext uri="{9D8B030D-6E8A-4147-A177-3AD203B41FA5}">
                      <a16:colId xmlns:a16="http://schemas.microsoft.com/office/drawing/2014/main" val="4286722765"/>
                    </a:ext>
                  </a:extLst>
                </a:gridCol>
                <a:gridCol w="323869">
                  <a:extLst>
                    <a:ext uri="{9D8B030D-6E8A-4147-A177-3AD203B41FA5}">
                      <a16:colId xmlns:a16="http://schemas.microsoft.com/office/drawing/2014/main" val="2042633797"/>
                    </a:ext>
                  </a:extLst>
                </a:gridCol>
                <a:gridCol w="435978">
                  <a:extLst>
                    <a:ext uri="{9D8B030D-6E8A-4147-A177-3AD203B41FA5}">
                      <a16:colId xmlns:a16="http://schemas.microsoft.com/office/drawing/2014/main" val="756268468"/>
                    </a:ext>
                  </a:extLst>
                </a:gridCol>
                <a:gridCol w="644936">
                  <a:extLst>
                    <a:ext uri="{9D8B030D-6E8A-4147-A177-3AD203B41FA5}">
                      <a16:colId xmlns:a16="http://schemas.microsoft.com/office/drawing/2014/main" val="661886063"/>
                    </a:ext>
                  </a:extLst>
                </a:gridCol>
              </a:tblGrid>
              <a:tr h="20372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endParaRPr kumimoji="0" lang="es-ES_tradnl" altLang="es-MX" sz="105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pitchFamily="34" charset="-128"/>
                        <a:cs typeface="Arial" panose="020B0604020202020204" pitchFamily="34" charset="0"/>
                      </a:endParaRPr>
                    </a:p>
                  </a:txBody>
                  <a:tcPr marL="30480" marR="30480" marT="38103" marB="38103" anchor="ctr" horzOverflow="overflow">
                    <a:lnL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EPEC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EPEC ∆</a:t>
                      </a:r>
                      <a:r>
                        <a:rPr kumimoji="0" lang="es-ES_tradnl" altLang="es-MX" sz="1050" b="1" i="1" u="none" strike="noStrike" cap="none" normalizeH="0" baseline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hns</a:t>
                      </a:r>
                      <a:endParaRPr kumimoji="0" lang="es-ES_tradnl" altLang="es-MX" sz="105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pitchFamily="34" charset="-128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EPEC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EPEC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∆</a:t>
                      </a:r>
                      <a:r>
                        <a:rPr kumimoji="0" lang="es-ES_tradnl" altLang="es-MX" sz="1050" b="1" i="1" u="none" strike="noStrike" cap="none" normalizeH="0" baseline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hns</a:t>
                      </a:r>
                      <a:endParaRPr kumimoji="0" lang="es-ES_tradnl" altLang="es-MX" sz="105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pitchFamily="34" charset="-128"/>
                        <a:cs typeface="Arial" panose="020B0604020202020204" pitchFamily="34" charset="0"/>
                      </a:endParaRPr>
                    </a:p>
                  </a:txBody>
                  <a:tcPr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108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pMPM-T3</a:t>
                      </a:r>
                      <a:endParaRPr kumimoji="0" lang="es-ES_tradnl" altLang="es-MX" sz="105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pitchFamily="34" charset="-128"/>
                        <a:cs typeface="Arial" panose="020B0604020202020204" pitchFamily="34" charset="0"/>
                      </a:endParaRPr>
                    </a:p>
                  </a:txBody>
                  <a:tcPr marL="30480" marR="304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   +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108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pT3GrlR</a:t>
                      </a:r>
                      <a:endParaRPr kumimoji="0" lang="es-ES_tradnl" altLang="es-MX" sz="105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pitchFamily="34" charset="-128"/>
                        <a:cs typeface="Arial" panose="020B0604020202020204" pitchFamily="34" charset="0"/>
                      </a:endParaRPr>
                    </a:p>
                  </a:txBody>
                  <a:tcPr marL="30480" marR="30480" marT="38103" marB="38103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   -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05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MS PGothic" pitchFamily="34" charset="-128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1280" marR="81280" marT="38103" marB="38103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7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s-ES_tradnl" altLang="es-MX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1280" marR="81280" marT="38103" marB="381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26" name="Rectangle 75">
            <a:extLst>
              <a:ext uri="{FF2B5EF4-FFF2-40B4-BE49-F238E27FC236}">
                <a16:creationId xmlns:a16="http://schemas.microsoft.com/office/drawing/2014/main" id="{FAB4E3ED-1ACC-7D48-B066-DDCEBD53E3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763" y="2004405"/>
            <a:ext cx="78581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s-MX" sz="1200" b="1" dirty="0">
                <a:latin typeface="Arial" charset="0"/>
                <a:ea typeface="ＭＳ Ｐゴシック" charset="0"/>
                <a:cs typeface="Verdana" charset="0"/>
              </a:rPr>
              <a:t>EspC</a:t>
            </a:r>
            <a:endParaRPr lang="es-ES_tradnl" sz="1200" b="1" dirty="0">
              <a:latin typeface="Arial" charset="0"/>
              <a:ea typeface="ＭＳ Ｐゴシック" charset="0"/>
              <a:cs typeface="Verdana" charset="0"/>
            </a:endParaRPr>
          </a:p>
        </p:txBody>
      </p:sp>
      <p:sp>
        <p:nvSpPr>
          <p:cNvPr id="32" name="Rectangle 76">
            <a:extLst>
              <a:ext uri="{FF2B5EF4-FFF2-40B4-BE49-F238E27FC236}">
                <a16:creationId xmlns:a16="http://schemas.microsoft.com/office/drawing/2014/main" id="{B3A6EB4D-7135-2341-911A-0EDF5DA0CA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8286" y="2919915"/>
            <a:ext cx="73129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s-MX" sz="1200" b="1" dirty="0">
                <a:latin typeface="Arial" charset="0"/>
                <a:ea typeface="ＭＳ Ｐゴシック" charset="0"/>
                <a:cs typeface="Verdana" charset="0"/>
              </a:rPr>
              <a:t>EspB/D</a:t>
            </a:r>
            <a:endParaRPr lang="es-ES_tradnl" sz="1200" b="1" dirty="0">
              <a:latin typeface="Arial" charset="0"/>
              <a:ea typeface="ＭＳ Ｐゴシック" charset="0"/>
              <a:cs typeface="Verdana" charset="0"/>
            </a:endParaRPr>
          </a:p>
        </p:txBody>
      </p:sp>
      <p:sp>
        <p:nvSpPr>
          <p:cNvPr id="33" name="Rectangle 77">
            <a:extLst>
              <a:ext uri="{FF2B5EF4-FFF2-40B4-BE49-F238E27FC236}">
                <a16:creationId xmlns:a16="http://schemas.microsoft.com/office/drawing/2014/main" id="{49CA440C-8060-554E-B024-440DFFE7CB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2174" y="3615143"/>
            <a:ext cx="57740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s-MX" sz="1200" b="1">
                <a:latin typeface="Arial" charset="0"/>
                <a:ea typeface="ＭＳ Ｐゴシック" charset="0"/>
                <a:cs typeface="Verdana" charset="0"/>
              </a:rPr>
              <a:t>EspA</a:t>
            </a:r>
            <a:endParaRPr lang="es-ES_tradnl" sz="1200" b="1">
              <a:latin typeface="Arial" charset="0"/>
              <a:ea typeface="ＭＳ Ｐゴシック" charset="0"/>
              <a:cs typeface="Verdana" charset="0"/>
            </a:endParaRPr>
          </a:p>
        </p:txBody>
      </p:sp>
      <p:cxnSp>
        <p:nvCxnSpPr>
          <p:cNvPr id="34" name="13 Conector recto de flecha">
            <a:extLst>
              <a:ext uri="{FF2B5EF4-FFF2-40B4-BE49-F238E27FC236}">
                <a16:creationId xmlns:a16="http://schemas.microsoft.com/office/drawing/2014/main" id="{7A299DE5-A087-3947-AB11-E355C2199244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361557" y="2142110"/>
            <a:ext cx="144000" cy="1588"/>
          </a:xfrm>
          <a:prstGeom prst="straightConnector1">
            <a:avLst/>
          </a:prstGeom>
          <a:noFill/>
          <a:ln w="222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5" name="13 Conector recto de flecha">
            <a:extLst>
              <a:ext uri="{FF2B5EF4-FFF2-40B4-BE49-F238E27FC236}">
                <a16:creationId xmlns:a16="http://schemas.microsoft.com/office/drawing/2014/main" id="{DD7B02FA-C6F6-BF47-ACA2-901550838757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361557" y="3057620"/>
            <a:ext cx="144000" cy="1588"/>
          </a:xfrm>
          <a:prstGeom prst="straightConnector1">
            <a:avLst/>
          </a:prstGeom>
          <a:noFill/>
          <a:ln w="222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6" name="13 Conector recto de flecha">
            <a:extLst>
              <a:ext uri="{FF2B5EF4-FFF2-40B4-BE49-F238E27FC236}">
                <a16:creationId xmlns:a16="http://schemas.microsoft.com/office/drawing/2014/main" id="{D4AA8884-71C9-584D-806F-A206B5F19C1C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361557" y="3752848"/>
            <a:ext cx="144000" cy="1588"/>
          </a:xfrm>
          <a:prstGeom prst="straightConnector1">
            <a:avLst/>
          </a:prstGeom>
          <a:noFill/>
          <a:ln w="222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id="{4D299B19-F995-2747-9B02-C3CCA0D268F8}"/>
              </a:ext>
            </a:extLst>
          </p:cNvPr>
          <p:cNvGrpSpPr/>
          <p:nvPr/>
        </p:nvGrpSpPr>
        <p:grpSpPr>
          <a:xfrm>
            <a:off x="6936439" y="2204923"/>
            <a:ext cx="798752" cy="276999"/>
            <a:chOff x="6780023" y="2797772"/>
            <a:chExt cx="798752" cy="276999"/>
          </a:xfrm>
        </p:grpSpPr>
        <p:sp>
          <p:nvSpPr>
            <p:cNvPr id="30" name="6 CuadroTexto">
              <a:extLst>
                <a:ext uri="{FF2B5EF4-FFF2-40B4-BE49-F238E27FC236}">
                  <a16:creationId xmlns:a16="http://schemas.microsoft.com/office/drawing/2014/main" id="{760A3B04-0DC0-874A-B3D3-0EFEB490C7B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780023" y="2797772"/>
              <a:ext cx="73930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s-MX" altLang="es-MX" sz="1200" b="1" dirty="0">
                  <a:latin typeface="Symbol" panose="05050102010706020507" pitchFamily="18" charset="2"/>
                </a:rPr>
                <a:t>a</a:t>
              </a:r>
              <a:r>
                <a:rPr lang="es-MX" altLang="es-MX" sz="1200" b="1" dirty="0">
                  <a:latin typeface="Century Gothic" panose="020B0502020202020204" pitchFamily="34" charset="0"/>
                </a:rPr>
                <a:t>-</a:t>
              </a:r>
              <a:r>
                <a:rPr lang="es-MX" altLang="es-MX" sz="1200" b="1" dirty="0"/>
                <a:t>EspA</a:t>
              </a:r>
            </a:p>
          </p:txBody>
        </p:sp>
        <p:cxnSp>
          <p:nvCxnSpPr>
            <p:cNvPr id="44" name="13 Conector recto de flecha">
              <a:extLst>
                <a:ext uri="{FF2B5EF4-FFF2-40B4-BE49-F238E27FC236}">
                  <a16:creationId xmlns:a16="http://schemas.microsoft.com/office/drawing/2014/main" id="{EF14B0B6-177E-AB4F-ACCD-233419B9443A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7434775" y="2935477"/>
              <a:ext cx="144000" cy="1588"/>
            </a:xfrm>
            <a:prstGeom prst="straightConnector1">
              <a:avLst/>
            </a:prstGeom>
            <a:noFill/>
            <a:ln w="222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EB4BEE7E-5EBD-0B4A-877C-7BE944A55CC8}"/>
              </a:ext>
            </a:extLst>
          </p:cNvPr>
          <p:cNvGrpSpPr/>
          <p:nvPr/>
        </p:nvGrpSpPr>
        <p:grpSpPr>
          <a:xfrm>
            <a:off x="6808123" y="3031043"/>
            <a:ext cx="927068" cy="276999"/>
            <a:chOff x="6651707" y="3623892"/>
            <a:chExt cx="927068" cy="276999"/>
          </a:xfrm>
        </p:grpSpPr>
        <p:sp>
          <p:nvSpPr>
            <p:cNvPr id="31" name="6 CuadroTexto">
              <a:extLst>
                <a:ext uri="{FF2B5EF4-FFF2-40B4-BE49-F238E27FC236}">
                  <a16:creationId xmlns:a16="http://schemas.microsoft.com/office/drawing/2014/main" id="{F59F011F-3976-E044-A28C-8A5CFA1FC2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51707" y="3623892"/>
              <a:ext cx="85311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es-MX" altLang="es-MX" sz="1200" b="1" dirty="0">
                  <a:latin typeface="Symbol" panose="05050102010706020507" pitchFamily="18" charset="2"/>
                </a:rPr>
                <a:t>a</a:t>
              </a:r>
              <a:r>
                <a:rPr lang="es-MX" altLang="es-MX" sz="1200" b="1" dirty="0">
                  <a:latin typeface="Century Gothic" panose="020B0502020202020204" pitchFamily="34" charset="0"/>
                </a:rPr>
                <a:t>-</a:t>
              </a:r>
              <a:r>
                <a:rPr lang="es-MX" altLang="es-MX" sz="1200" b="1" dirty="0"/>
                <a:t>Intimin</a:t>
              </a:r>
            </a:p>
          </p:txBody>
        </p:sp>
        <p:cxnSp>
          <p:nvCxnSpPr>
            <p:cNvPr id="45" name="13 Conector recto de flecha">
              <a:extLst>
                <a:ext uri="{FF2B5EF4-FFF2-40B4-BE49-F238E27FC236}">
                  <a16:creationId xmlns:a16="http://schemas.microsoft.com/office/drawing/2014/main" id="{763E4E86-C622-384C-B1D4-DBEF435FF62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7434775" y="3761597"/>
              <a:ext cx="144000" cy="1588"/>
            </a:xfrm>
            <a:prstGeom prst="straightConnector1">
              <a:avLst/>
            </a:prstGeom>
            <a:noFill/>
            <a:ln w="222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B011A811-3FBD-6C4A-9726-B5F9645962E8}"/>
              </a:ext>
            </a:extLst>
          </p:cNvPr>
          <p:cNvGrpSpPr/>
          <p:nvPr/>
        </p:nvGrpSpPr>
        <p:grpSpPr>
          <a:xfrm>
            <a:off x="6916392" y="3162987"/>
            <a:ext cx="818799" cy="276999"/>
            <a:chOff x="6759976" y="3755836"/>
            <a:chExt cx="818799" cy="276999"/>
          </a:xfrm>
        </p:grpSpPr>
        <p:sp>
          <p:nvSpPr>
            <p:cNvPr id="29" name="6 CuadroTexto">
              <a:extLst>
                <a:ext uri="{FF2B5EF4-FFF2-40B4-BE49-F238E27FC236}">
                  <a16:creationId xmlns:a16="http://schemas.microsoft.com/office/drawing/2014/main" id="{04809247-65A5-5340-95C5-732E2AB521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759976" y="3755836"/>
              <a:ext cx="7473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s-MX" altLang="es-MX" sz="1200" b="1" dirty="0">
                  <a:latin typeface="Symbol" panose="05050102010706020507" pitchFamily="18" charset="2"/>
                </a:rPr>
                <a:t>a</a:t>
              </a:r>
              <a:r>
                <a:rPr lang="es-MX" altLang="es-MX" sz="1200" b="1" dirty="0">
                  <a:latin typeface="Century Gothic" panose="020B0502020202020204" pitchFamily="34" charset="0"/>
                </a:rPr>
                <a:t>-</a:t>
              </a:r>
              <a:r>
                <a:rPr lang="es-MX" altLang="es-MX" sz="1200" b="1" dirty="0"/>
                <a:t>DnaK</a:t>
              </a:r>
            </a:p>
          </p:txBody>
        </p:sp>
        <p:cxnSp>
          <p:nvCxnSpPr>
            <p:cNvPr id="46" name="13 Conector recto de flecha">
              <a:extLst>
                <a:ext uri="{FF2B5EF4-FFF2-40B4-BE49-F238E27FC236}">
                  <a16:creationId xmlns:a16="http://schemas.microsoft.com/office/drawing/2014/main" id="{34A0D123-7158-094D-9FB2-9982515EC8C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7434775" y="3893541"/>
              <a:ext cx="144000" cy="1588"/>
            </a:xfrm>
            <a:prstGeom prst="straightConnector1">
              <a:avLst/>
            </a:prstGeom>
            <a:noFill/>
            <a:ln w="222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942FE228-8369-3570-F06D-D595B1C7989D}"/>
              </a:ext>
            </a:extLst>
          </p:cNvPr>
          <p:cNvSpPr txBox="1"/>
          <p:nvPr/>
        </p:nvSpPr>
        <p:spPr>
          <a:xfrm>
            <a:off x="336832" y="4466784"/>
            <a:ext cx="11752885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1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rlR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presses the expression and secretion of proteins encoded in the LEE island under conditions in which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rl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s not the main activator of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er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ofile of secreted proteins from WT EPEC and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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ns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trains carrying the empty vector pMPMT-3 or its derivative pT3GrlR. Bacteria were grown under static conditions in 50 ml DMEM at 37°C with 5% CO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at an OD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600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0.8. Secreted proteins were concentrated from culture supernatants by TCA precipitation and separated by 12% SDS-PAGE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otal extracts were prepared from the same strains described in (A) grown in 50 ml DMEM and incubated under shaking (37°C with shaking) and static (37°C with 5% CO2) conditions, at an OD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600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0.8. Extracts were separated by 12% SDS-PAGE and intimin and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sp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expression was analyzed by Western blotting using anti-intimin and anti-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sp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tibodies. As a control for protein loading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naK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expression was also analyzed using anti-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naK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tibodies.</a:t>
            </a:r>
            <a:endParaRPr lang="es-MX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5479964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34</Words>
  <Application>Microsoft Macintosh PowerPoint</Application>
  <PresentationFormat>Panorámica</PresentationFormat>
  <Paragraphs>5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entury Gothic</vt:lpstr>
      <vt:lpstr>Symbol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RISTINA LARA - OCHOA</dc:creator>
  <cp:lastModifiedBy>CRISTINA LARA - OCHOA</cp:lastModifiedBy>
  <cp:revision>1</cp:revision>
  <dcterms:created xsi:type="dcterms:W3CDTF">2022-10-06T17:41:27Z</dcterms:created>
  <dcterms:modified xsi:type="dcterms:W3CDTF">2022-10-06T17:43:26Z</dcterms:modified>
</cp:coreProperties>
</file>